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60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52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244" autoAdjust="0"/>
    <p:restoredTop sz="95214" autoAdjust="0"/>
  </p:normalViewPr>
  <p:slideViewPr>
    <p:cSldViewPr showGuides="1">
      <p:cViewPr varScale="1">
        <p:scale>
          <a:sx n="85" d="100"/>
          <a:sy n="85" d="100"/>
        </p:scale>
        <p:origin x="984" y="48"/>
      </p:cViewPr>
      <p:guideLst>
        <p:guide orient="horz" pos="346"/>
        <p:guide pos="52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4021142" y="2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/>
          <a:lstStyle>
            <a:lvl1pPr algn="r">
              <a:defRPr sz="1100"/>
            </a:lvl1pPr>
          </a:lstStyle>
          <a:p>
            <a:fld id="{7B015BB1-1E7A-4E6C-89B7-0C5BC5328040}" type="datetimeFigureOut">
              <a:rPr kumimoji="1" lang="ja-JP" altLang="en-US" smtClean="0"/>
              <a:t>2017/3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721853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 anchor="b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4021142" y="9721853"/>
            <a:ext cx="3076575" cy="512763"/>
          </a:xfrm>
          <a:prstGeom prst="rect">
            <a:avLst/>
          </a:prstGeom>
        </p:spPr>
        <p:txBody>
          <a:bodyPr vert="horz" lIns="91408" tIns="45704" rIns="91408" bIns="45704" rtlCol="0" anchor="b"/>
          <a:lstStyle>
            <a:lvl1pPr algn="r">
              <a:defRPr sz="1100"/>
            </a:lvl1pPr>
          </a:lstStyle>
          <a:p>
            <a:fld id="{5F431AF3-5A39-4883-B7C5-8AAE25E8C2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8518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6" y="1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/>
          <a:lstStyle>
            <a:lvl1pPr algn="r">
              <a:defRPr sz="1100"/>
            </a:lvl1pPr>
          </a:lstStyle>
          <a:p>
            <a:fld id="{6048D5DD-01E0-4355-93B1-2C55B9C27FBA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0600" y="766763"/>
            <a:ext cx="5118100" cy="3838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62" tIns="47332" rIns="94662" bIns="4733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1" y="4861442"/>
            <a:ext cx="5679440" cy="4605576"/>
          </a:xfrm>
          <a:prstGeom prst="rect">
            <a:avLst/>
          </a:prstGeom>
        </p:spPr>
        <p:txBody>
          <a:bodyPr vert="horz" lIns="94662" tIns="47332" rIns="94662" bIns="47332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721107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 anchor="b"/>
          <a:lstStyle>
            <a:lvl1pPr algn="l">
              <a:defRPr sz="11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6" y="9721107"/>
            <a:ext cx="3076363" cy="511731"/>
          </a:xfrm>
          <a:prstGeom prst="rect">
            <a:avLst/>
          </a:prstGeom>
        </p:spPr>
        <p:txBody>
          <a:bodyPr vert="horz" lIns="94662" tIns="47332" rIns="94662" bIns="47332" rtlCol="0" anchor="b"/>
          <a:lstStyle>
            <a:lvl1pPr algn="r">
              <a:defRPr sz="1100"/>
            </a:lvl1pPr>
          </a:lstStyle>
          <a:p>
            <a:fld id="{95BD2EC4-4567-48DF-AA7C-ED31B69D9C6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46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BD2EC4-4567-48DF-AA7C-ED31B69D9C60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2967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869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732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335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596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611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238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722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844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352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9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729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E2A8B-922C-4070-A735-8B7DABB67288}" type="datetimeFigureOut">
              <a:rPr kumimoji="1" lang="ja-JP" altLang="en-US" smtClean="0"/>
              <a:pPr/>
              <a:t>2017/3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74D03-68AC-4560-981E-7A63C195429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7132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0254236"/>
              </p:ext>
            </p:extLst>
          </p:nvPr>
        </p:nvGraphicFramePr>
        <p:xfrm>
          <a:off x="250828" y="476672"/>
          <a:ext cx="8722986" cy="60353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0000"/>
                <a:gridCol w="900000"/>
                <a:gridCol w="1044000"/>
                <a:gridCol w="684000"/>
                <a:gridCol w="320176"/>
                <a:gridCol w="648000"/>
                <a:gridCol w="684000"/>
                <a:gridCol w="218150"/>
                <a:gridCol w="684000"/>
                <a:gridCol w="684000"/>
                <a:gridCol w="218150"/>
                <a:gridCol w="684000"/>
                <a:gridCol w="684000"/>
                <a:gridCol w="218150"/>
                <a:gridCol w="684000"/>
                <a:gridCol w="188360"/>
              </a:tblGrid>
              <a:tr h="324000"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cancer </a:t>
                      </a:r>
                      <a:endParaRPr lang="en-US" sz="120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</a:t>
                      </a:r>
                    </a:p>
                    <a:p>
                      <a:pPr algn="ctr" rtl="0" fontAlgn="ctr"/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µg/m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sidual </a:t>
                      </a:r>
                      <a:r>
                        <a:rPr lang="ja-JP" alt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ncentration in water </a:t>
                      </a: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µg/mL)</a:t>
                      </a:r>
                      <a:endParaRPr lang="en-US" altLang="ja-JP" sz="12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2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esidual concentration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in urine </a:t>
                      </a: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µg/mL)</a:t>
                      </a:r>
                      <a:endParaRPr lang="en-US" altLang="ja-JP" sz="1200" b="0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24000"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－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+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－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e carbon（+）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8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E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3.6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4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7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3.2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5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1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5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2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8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pi-AD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6.5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1.8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8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9.0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2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7.6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6 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1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1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9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3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T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3.5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rowSpan="12"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T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.4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5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6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.5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.9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7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1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5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8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lang="en-US" altLang="ja-JP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-1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1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2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0.8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6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.3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2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 </a:t>
                      </a: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T-1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0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9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5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.1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96.6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4.4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2.5 </a:t>
                      </a: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7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.7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6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.9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.8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/>
                </a:tc>
              </a:tr>
              <a:tr h="17688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2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2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 </a:t>
                      </a: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202" marR="4202" marT="4202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正方形/長方形 4"/>
          <p:cNvSpPr/>
          <p:nvPr/>
        </p:nvSpPr>
        <p:spPr>
          <a:xfrm>
            <a:off x="321788" y="6495727"/>
            <a:ext cx="87849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erical value indicated mean ± standar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viation (n=4), Th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value indicated hazard ratio by unpaired t-test.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21788" y="112652"/>
            <a:ext cx="80864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ndix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sorption properties of the activated carbon to the urinary anticancer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ug (continued). </a:t>
            </a:r>
          </a:p>
        </p:txBody>
      </p:sp>
    </p:spTree>
    <p:extLst>
      <p:ext uri="{BB962C8B-B14F-4D97-AF65-F5344CB8AC3E}">
        <p14:creationId xmlns:p14="http://schemas.microsoft.com/office/powerpoint/2010/main" val="305089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01</TotalTime>
  <Words>443</Words>
  <Application>Microsoft Office PowerPoint</Application>
  <PresentationFormat>画面に合わせる (4:3)</PresentationFormat>
  <Paragraphs>38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ya</dc:creator>
  <cp:lastModifiedBy>junya</cp:lastModifiedBy>
  <cp:revision>585</cp:revision>
  <cp:lastPrinted>2017-01-25T01:09:51Z</cp:lastPrinted>
  <dcterms:created xsi:type="dcterms:W3CDTF">2016-11-19T06:04:05Z</dcterms:created>
  <dcterms:modified xsi:type="dcterms:W3CDTF">2017-03-01T09:33:28Z</dcterms:modified>
</cp:coreProperties>
</file>